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98" d="100"/>
          <a:sy n="98" d="100"/>
        </p:scale>
        <p:origin x="-150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45EDB-4439-4BE8-9D5A-42425305BB47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EFC78-46F8-4E82-BFBE-B572DAC81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15644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45EDB-4439-4BE8-9D5A-42425305BB47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EFC78-46F8-4E82-BFBE-B572DAC81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11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45EDB-4439-4BE8-9D5A-42425305BB47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EFC78-46F8-4E82-BFBE-B572DAC81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8742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45EDB-4439-4BE8-9D5A-42425305BB47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EFC78-46F8-4E82-BFBE-B572DAC81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4867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45EDB-4439-4BE8-9D5A-42425305BB47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EFC78-46F8-4E82-BFBE-B572DAC81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1975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45EDB-4439-4BE8-9D5A-42425305BB47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EFC78-46F8-4E82-BFBE-B572DAC81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2514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45EDB-4439-4BE8-9D5A-42425305BB47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EFC78-46F8-4E82-BFBE-B572DAC81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01328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45EDB-4439-4BE8-9D5A-42425305BB47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EFC78-46F8-4E82-BFBE-B572DAC81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0137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45EDB-4439-4BE8-9D5A-42425305BB47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EFC78-46F8-4E82-BFBE-B572DAC81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7919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45EDB-4439-4BE8-9D5A-42425305BB47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EFC78-46F8-4E82-BFBE-B572DAC81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86826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545EDB-4439-4BE8-9D5A-42425305BB47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EFC78-46F8-4E82-BFBE-B572DAC81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0345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545EDB-4439-4BE8-9D5A-42425305BB47}" type="datetimeFigureOut">
              <a:rPr kumimoji="1" lang="ja-JP" altLang="en-US" smtClean="0"/>
              <a:t>2013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5EFC78-46F8-4E82-BFBE-B572DAC811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8607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グループ化 4"/>
          <p:cNvGrpSpPr/>
          <p:nvPr/>
        </p:nvGrpSpPr>
        <p:grpSpPr>
          <a:xfrm>
            <a:off x="418539" y="1268760"/>
            <a:ext cx="8257917" cy="4464496"/>
            <a:chOff x="418539" y="1268760"/>
            <a:chExt cx="8257917" cy="4464496"/>
          </a:xfrm>
        </p:grpSpPr>
        <p:pic>
          <p:nvPicPr>
            <p:cNvPr id="2053" name="Picture 5" descr="J:\FUJIKAWA\NIFTS\研究\グリーニング\PCR効率\2012_06_20\健全2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4000" contrast="3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8539" y="1520788"/>
              <a:ext cx="1273726" cy="1800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4" name="Picture 6" descr="J:\FUJIKAWA\NIFTS\研究\グリーニング\PCR効率\2012_06_20\Ishi1-A2.tif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14000" contrast="2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86691" y="1520788"/>
              <a:ext cx="1273726" cy="1800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5" name="Picture 7" descr="J:\FUJIKAWA\NIFTS\研究\グリーニング\PCR効率\2012_06_20\Ishi1-B2.tif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9000" contrast="3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87585" y="1520788"/>
              <a:ext cx="1273726" cy="1800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6" name="Picture 8" descr="J:\FUJIKAWA\NIFTS\研究\グリーニング\PCR効率\2012_06_20\Ishi1-C2.tif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5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95003" y="1520788"/>
              <a:ext cx="1273727" cy="1800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8" name="Picture 10" descr="J:\FUJIKAWA\NIFTS\研究\グリーニング\PCR効率\2012_06_20\KIN1-B2.tif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10000" contrast="4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45646" y="1520788"/>
              <a:ext cx="1273726" cy="1800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9" name="Picture 11" descr="J:\FUJIKAWA\NIFTS\研究\グリーニング\PCR効率\2012_06_20\Ishi3-A2.tif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4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21579" y="3933056"/>
              <a:ext cx="1273726" cy="1800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61" name="Picture 13" descr="J:\FUJIKAWA\NIFTS\研究\グリーニング\PCR効率\2012_06_20\OK901-A2.tif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14000" contrast="3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8539" y="3933056"/>
              <a:ext cx="1273726" cy="1800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62" name="Picture 14" descr="J:\FUJIKAWA\NIFTS\研究\グリーニング\PCR効率\2012_06_20\OK901-B2.tif"/>
            <p:cNvPicPr>
              <a:picLocks noChangeAspect="1" noChangeArrowheads="1"/>
            </p:cNvPicPr>
            <p:nvPr/>
          </p:nvPicPr>
          <p:blipFill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11000" contrast="3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92829" y="3933056"/>
              <a:ext cx="1273726" cy="1800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63" name="Picture 15" descr="J:\FUJIKAWA\NIFTS\研究\グリーニング\PCR効率\2012_06_20\Miyako13-A2.tif"/>
            <p:cNvPicPr>
              <a:picLocks noChangeAspect="1" noChangeArrowheads="1"/>
            </p:cNvPicPr>
            <p:nvPr/>
          </p:nvPicPr>
          <p:blipFill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12000" contrast="3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03315" y="3930132"/>
              <a:ext cx="1273141" cy="179937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64" name="Picture 16" descr="J:\FUJIKAWA\NIFTS\研究\グリーニング\PCR効率\2012_06_28\KIN1-C2.tif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6000" contras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03315" y="1520788"/>
              <a:ext cx="1273141" cy="179937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65" name="Picture 17" descr="J:\FUJIKAWA\NIFTS\研究\グリーニング\PCR効率\2012_06_28\Ishi3-B2.tif"/>
            <p:cNvPicPr>
              <a:picLocks noChangeAspect="1" noChangeArrowheads="1"/>
            </p:cNvPicPr>
            <p:nvPr/>
          </p:nvPicPr>
          <p:blipFill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12000" contrast="5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95004" y="3933056"/>
              <a:ext cx="1273726" cy="180019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66" name="Picture 18" descr="J:\FUJIKAWA\NIFTS\研究\グリーニング\PCR効率\2012_06_28\Ishi4-A2.tif"/>
            <p:cNvPicPr>
              <a:picLocks noChangeAspect="1" noChangeArrowheads="1"/>
            </p:cNvPicPr>
            <p:nvPr/>
          </p:nvPicPr>
          <p:blipFill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6000" contrast="4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28193" y="3928781"/>
              <a:ext cx="1273726" cy="180019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テキスト ボックス 1"/>
            <p:cNvSpPr txBox="1"/>
            <p:nvPr/>
          </p:nvSpPr>
          <p:spPr>
            <a:xfrm>
              <a:off x="617622" y="1268760"/>
              <a:ext cx="8755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1. Healthy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79" name="テキスト ボックス 78"/>
            <p:cNvSpPr txBox="1"/>
            <p:nvPr/>
          </p:nvSpPr>
          <p:spPr>
            <a:xfrm>
              <a:off x="1797531" y="1268760"/>
              <a:ext cx="1114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2. Ishigaki1-A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80" name="テキスト ボックス 79"/>
            <p:cNvSpPr txBox="1"/>
            <p:nvPr/>
          </p:nvSpPr>
          <p:spPr>
            <a:xfrm>
              <a:off x="3278324" y="1268760"/>
              <a:ext cx="1114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3. Ishigaki1-B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81" name="テキスト ボックス 80"/>
            <p:cNvSpPr txBox="1"/>
            <p:nvPr/>
          </p:nvSpPr>
          <p:spPr>
            <a:xfrm>
              <a:off x="4642469" y="1268760"/>
              <a:ext cx="11224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4. Ishigaki1-C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83" name="テキスト ボックス 82"/>
            <p:cNvSpPr txBox="1"/>
            <p:nvPr/>
          </p:nvSpPr>
          <p:spPr>
            <a:xfrm>
              <a:off x="6215043" y="1268760"/>
              <a:ext cx="8162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5</a:t>
              </a:r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. Kin1-A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84" name="テキスト ボックス 83"/>
            <p:cNvSpPr txBox="1"/>
            <p:nvPr/>
          </p:nvSpPr>
          <p:spPr>
            <a:xfrm>
              <a:off x="562555" y="3660665"/>
              <a:ext cx="9877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7. OK901-A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85" name="テキスト ボックス 84"/>
            <p:cNvSpPr txBox="1"/>
            <p:nvPr/>
          </p:nvSpPr>
          <p:spPr>
            <a:xfrm>
              <a:off x="1864040" y="3660665"/>
              <a:ext cx="9877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8. OK901-B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86" name="テキスト ボックス 85"/>
            <p:cNvSpPr txBox="1"/>
            <p:nvPr/>
          </p:nvSpPr>
          <p:spPr>
            <a:xfrm>
              <a:off x="3281512" y="3660665"/>
              <a:ext cx="1114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9. Ishigaki3-A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88" name="テキスト ボックス 87"/>
            <p:cNvSpPr txBox="1"/>
            <p:nvPr/>
          </p:nvSpPr>
          <p:spPr>
            <a:xfrm>
              <a:off x="7372835" y="3656914"/>
              <a:ext cx="12506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12. Miyako13-A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89" name="テキスト ボックス 88"/>
            <p:cNvSpPr txBox="1"/>
            <p:nvPr/>
          </p:nvSpPr>
          <p:spPr>
            <a:xfrm>
              <a:off x="7618754" y="1278091"/>
              <a:ext cx="8162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6</a:t>
              </a:r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. Kin1-B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90" name="テキスト ボックス 89"/>
            <p:cNvSpPr txBox="1"/>
            <p:nvPr/>
          </p:nvSpPr>
          <p:spPr>
            <a:xfrm>
              <a:off x="4613635" y="3645024"/>
              <a:ext cx="11993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10. Ishigaki3-B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91" name="テキスト ボックス 90"/>
            <p:cNvSpPr txBox="1"/>
            <p:nvPr/>
          </p:nvSpPr>
          <p:spPr>
            <a:xfrm>
              <a:off x="6045646" y="3653603"/>
              <a:ext cx="11993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 smtClean="0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11. Ishigaki4-A</a:t>
              </a:r>
              <a:endParaRPr kumimoji="1" lang="ja-JP" altLang="en-US" sz="1200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3" name="テキスト ボックス 2"/>
            <p:cNvSpPr txBox="1"/>
            <p:nvPr/>
          </p:nvSpPr>
          <p:spPr>
            <a:xfrm>
              <a:off x="3364084" y="3059378"/>
              <a:ext cx="9204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 err="1" smtClean="0">
                  <a:solidFill>
                    <a:srgbClr val="FF000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Symtomatic</a:t>
              </a:r>
              <a:endParaRPr kumimoji="1" lang="ja-JP" altLang="en-US" sz="11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94" name="テキスト ボックス 93"/>
            <p:cNvSpPr txBox="1"/>
            <p:nvPr/>
          </p:nvSpPr>
          <p:spPr>
            <a:xfrm>
              <a:off x="4703899" y="3059378"/>
              <a:ext cx="9204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 err="1" smtClean="0">
                  <a:solidFill>
                    <a:srgbClr val="FF000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Symtomatic</a:t>
              </a:r>
              <a:endParaRPr kumimoji="1" lang="ja-JP" altLang="en-US" sz="11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95" name="テキスト ボックス 94"/>
            <p:cNvSpPr txBox="1"/>
            <p:nvPr/>
          </p:nvSpPr>
          <p:spPr>
            <a:xfrm>
              <a:off x="654472" y="5471646"/>
              <a:ext cx="9204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 err="1" smtClean="0">
                  <a:solidFill>
                    <a:srgbClr val="FF000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Symtomatic</a:t>
              </a:r>
              <a:endParaRPr kumimoji="1" lang="ja-JP" altLang="en-US" sz="11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96" name="テキスト ボックス 95"/>
            <p:cNvSpPr txBox="1"/>
            <p:nvPr/>
          </p:nvSpPr>
          <p:spPr>
            <a:xfrm>
              <a:off x="6185105" y="5467370"/>
              <a:ext cx="9204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 err="1" smtClean="0">
                  <a:solidFill>
                    <a:srgbClr val="FF000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Symtomatic</a:t>
              </a:r>
              <a:endParaRPr kumimoji="1" lang="ja-JP" altLang="en-US" sz="11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97" name="テキスト ボックス 96"/>
            <p:cNvSpPr txBox="1"/>
            <p:nvPr/>
          </p:nvSpPr>
          <p:spPr>
            <a:xfrm>
              <a:off x="7638663" y="3052451"/>
              <a:ext cx="9204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dirty="0" err="1" smtClean="0">
                  <a:solidFill>
                    <a:srgbClr val="FF0000"/>
                  </a:solidFill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Symtomatic</a:t>
              </a:r>
              <a:endParaRPr kumimoji="1" lang="ja-JP" altLang="en-US" sz="1100" dirty="0">
                <a:solidFill>
                  <a:srgbClr val="FF000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</p:grpSp>
      <p:sp>
        <p:nvSpPr>
          <p:cNvPr id="38" name="テキスト ボックス 37"/>
          <p:cNvSpPr txBox="1"/>
          <p:nvPr/>
        </p:nvSpPr>
        <p:spPr>
          <a:xfrm>
            <a:off x="3968973" y="107597"/>
            <a:ext cx="11849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1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73596" y="5925372"/>
            <a:ext cx="899102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1. </a:t>
            </a: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ppearances </a:t>
            </a:r>
            <a:r>
              <a:rPr kumimoji="1" lang="en-US" altLang="ja-JP" sz="110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of collected leaves. Totally 11 Las-infected and 1 healthy citrus leaves were tested. From individual trees, 3 leaves were collected and used for preparation of templates for PCRs. Of these leaves, Ishigaki1-B, Ishigaki1-C, Kin1-B, OK908-A, and Ishigaki4-A were symptomatic. Other leaves were asymptomatic like as healthy leaves.</a:t>
            </a:r>
            <a:endParaRPr kumimoji="1" lang="ja-JP" altLang="en-US" sz="1100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1125197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</TotalTime>
  <Words>105</Words>
  <Application>Microsoft Office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jikawa</dc:creator>
  <cp:lastModifiedBy>Fujikawa</cp:lastModifiedBy>
  <cp:revision>6</cp:revision>
  <cp:lastPrinted>2012-08-17T01:16:06Z</cp:lastPrinted>
  <dcterms:created xsi:type="dcterms:W3CDTF">2012-08-17T00:39:08Z</dcterms:created>
  <dcterms:modified xsi:type="dcterms:W3CDTF">2013-01-23T00:39:53Z</dcterms:modified>
</cp:coreProperties>
</file>